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9.pct" ContentType="image/x-pict"/>
  <Override PartName="/ppt/media/image13.pct" ContentType="image/x-pict"/>
  <Override PartName="/ppt/media/image2.png" ContentType="image/png"/>
  <Override PartName="/ppt/media/image16.pct" ContentType="image/x-pict"/>
  <Override PartName="/ppt/media/image15.pct" ContentType="image/x-pict"/>
  <Override PartName="/ppt/media/image14.pct" ContentType="image/x-pict"/>
  <Override PartName="/ppt/media/image3.pct" ContentType="image/x-pict"/>
  <Override PartName="/ppt/media/image4.pct" ContentType="image/x-pict"/>
  <Override PartName="/ppt/media/image5.pct" ContentType="image/x-pict"/>
  <Override PartName="/ppt/media/image10.pct" ContentType="image/x-pict"/>
  <Override PartName="/ppt/media/image6.pct" ContentType="image/x-pict"/>
  <Override PartName="/ppt/media/image11.pct" ContentType="image/x-pict"/>
  <Override PartName="/ppt/media/image7.pct" ContentType="image/x-pict"/>
  <Override PartName="/ppt/media/image1.png" ContentType="image/png"/>
  <Override PartName="/ppt/media/image12.pct" ContentType="image/x-pict"/>
  <Override PartName="/ppt/media/image8.pct" ContentType="image/x-pi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AB7A29-81A1-420A-ADD4-C9619050ACD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49CFAC-4775-49B5-AF4D-87B429E34C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C66023-C898-449C-AD65-C8FE9153D87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230153-B3D8-43BB-863A-CB54C61F7A3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F8CE9A-B3C5-4843-A685-6FA290E8883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E3389F-9C33-4F7F-94CE-15A7158591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F411E8-F94E-43C8-A2CB-FAA09D3A1BB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4DC696-0EAD-4496-A931-099B5DD242F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B103EF-2699-4CDC-9088-D314B907BC0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25D92B-77B9-45ED-A9BB-59FDFAE444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0267E3-1153-4991-BD34-6492085188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45EB7A-697D-4092-968D-6E3EF1B4DD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80296E0-E280-4F16-A879-592F3086C66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ct"/><Relationship Id="rId2" Type="http://schemas.openxmlformats.org/officeDocument/2006/relationships/image" Target="../media/image4.pct"/><Relationship Id="rId3" Type="http://schemas.openxmlformats.org/officeDocument/2006/relationships/image" Target="../media/image5.pct"/><Relationship Id="rId4" Type="http://schemas.openxmlformats.org/officeDocument/2006/relationships/image" Target="../media/image6.pct"/><Relationship Id="rId5" Type="http://schemas.openxmlformats.org/officeDocument/2006/relationships/slideLayout" Target="../slideLayouts/slideLayout2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7.pct"/><Relationship Id="rId2" Type="http://schemas.openxmlformats.org/officeDocument/2006/relationships/image" Target="../media/image8.pct"/><Relationship Id="rId3" Type="http://schemas.openxmlformats.org/officeDocument/2006/relationships/image" Target="../media/image9.pct"/><Relationship Id="rId4" Type="http://schemas.openxmlformats.org/officeDocument/2006/relationships/image" Target="../media/image10.pct"/><Relationship Id="rId5" Type="http://schemas.openxmlformats.org/officeDocument/2006/relationships/image" Target="../media/image11.pct"/><Relationship Id="rId6" Type="http://schemas.openxmlformats.org/officeDocument/2006/relationships/image" Target="../media/image12.pct"/><Relationship Id="rId7" Type="http://schemas.openxmlformats.org/officeDocument/2006/relationships/slideLayout" Target="../slideLayouts/slideLayout2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3.pct"/><Relationship Id="rId2" Type="http://schemas.openxmlformats.org/officeDocument/2006/relationships/image" Target="../media/image14.pct"/><Relationship Id="rId3" Type="http://schemas.openxmlformats.org/officeDocument/2006/relationships/image" Target="../media/image15.pct"/><Relationship Id="rId4" Type="http://schemas.openxmlformats.org/officeDocument/2006/relationships/image" Target="../media/image16.pct"/><Relationship Id="rId5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040" y="44280"/>
            <a:ext cx="2296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upplement Figure 7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0" y="847800"/>
          <a:ext cx="9144000" cy="50562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3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0" y="847800"/>
                    <a:ext cx="9144000" cy="5056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"/>
          <p:cNvSpPr/>
          <p:nvPr/>
        </p:nvSpPr>
        <p:spPr>
          <a:xfrm>
            <a:off x="5400" y="44280"/>
            <a:ext cx="230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upplement Figure 7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5" name=""/>
          <p:cNvGraphicFramePr/>
          <p:nvPr/>
        </p:nvGraphicFramePr>
        <p:xfrm>
          <a:off x="76320" y="1060560"/>
          <a:ext cx="9067680" cy="49244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6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6320" y="1060560"/>
                    <a:ext cx="9067680" cy="4924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" descr=""/>
          <p:cNvPicPr/>
          <p:nvPr/>
        </p:nvPicPr>
        <p:blipFill>
          <a:blip r:embed="rId1"/>
          <a:stretch/>
        </p:blipFill>
        <p:spPr>
          <a:xfrm>
            <a:off x="1066680" y="200160"/>
            <a:ext cx="3135600" cy="3135240"/>
          </a:xfrm>
          <a:prstGeom prst="rect">
            <a:avLst/>
          </a:prstGeom>
          <a:ln w="0">
            <a:noFill/>
          </a:ln>
        </p:spPr>
      </p:pic>
      <p:sp>
        <p:nvSpPr>
          <p:cNvPr id="48" name=""/>
          <p:cNvSpPr/>
          <p:nvPr/>
        </p:nvSpPr>
        <p:spPr>
          <a:xfrm>
            <a:off x="1869120" y="3254400"/>
            <a:ext cx="59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DA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830960" y="6321600"/>
            <a:ext cx="59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DA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5412600" y="6359400"/>
            <a:ext cx="59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DA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5402880" y="3224160"/>
            <a:ext cx="59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DA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6586560" y="3224160"/>
            <a:ext cx="743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UCH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6489720" y="6369120"/>
            <a:ext cx="743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UCH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965320" y="6332400"/>
            <a:ext cx="743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UCH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3031920" y="3224160"/>
            <a:ext cx="743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UCH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282040" y="3632040"/>
            <a:ext cx="1093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emal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5793480" y="3632040"/>
            <a:ext cx="1093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emal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5898240" y="555480"/>
            <a:ext cx="8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Mal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2431080" y="555480"/>
            <a:ext cx="8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Mal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2221560" y="299880"/>
            <a:ext cx="1131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Z-scor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5425560" y="299880"/>
            <a:ext cx="1791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qRT-PCR (2</a:t>
            </a:r>
            <a:r>
              <a:rPr b="1" lang="en-US" sz="1800" spc="-1" strike="noStrike" baseline="30000">
                <a:solidFill>
                  <a:srgbClr val="000000"/>
                </a:solidFill>
                <a:latin typeface="Arial"/>
              </a:rPr>
              <a:t>-</a:t>
            </a:r>
            <a:r>
              <a:rPr b="1" lang="en-US" sz="1800" spc="-1" strike="noStrike" baseline="30000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1" lang="en-US" sz="1800" spc="-1" strike="noStrike" baseline="30000">
                <a:solidFill>
                  <a:srgbClr val="000000"/>
                </a:solidFill>
                <a:latin typeface="Arial"/>
              </a:rPr>
              <a:t>Ct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2" name="" descr=""/>
          <p:cNvPicPr/>
          <p:nvPr/>
        </p:nvPicPr>
        <p:blipFill>
          <a:blip r:embed="rId2"/>
          <a:stretch/>
        </p:blipFill>
        <p:spPr>
          <a:xfrm>
            <a:off x="4495680" y="3276720"/>
            <a:ext cx="3246480" cy="3200400"/>
          </a:xfrm>
          <a:prstGeom prst="rect">
            <a:avLst/>
          </a:prstGeom>
          <a:ln w="0">
            <a:noFill/>
          </a:ln>
        </p:spPr>
      </p:pic>
      <p:pic>
        <p:nvPicPr>
          <p:cNvPr id="63" name="" descr=""/>
          <p:cNvPicPr/>
          <p:nvPr/>
        </p:nvPicPr>
        <p:blipFill>
          <a:blip r:embed="rId3"/>
          <a:stretch/>
        </p:blipFill>
        <p:spPr>
          <a:xfrm>
            <a:off x="1066680" y="3295800"/>
            <a:ext cx="3171960" cy="3171600"/>
          </a:xfrm>
          <a:prstGeom prst="rect">
            <a:avLst/>
          </a:prstGeom>
          <a:ln w="0">
            <a:noFill/>
          </a:ln>
        </p:spPr>
      </p:pic>
      <p:sp>
        <p:nvSpPr>
          <p:cNvPr id="64" name=""/>
          <p:cNvSpPr/>
          <p:nvPr/>
        </p:nvSpPr>
        <p:spPr>
          <a:xfrm>
            <a:off x="5040" y="44280"/>
            <a:ext cx="2296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upplement Figure 7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" name="" descr=""/>
          <p:cNvPicPr/>
          <p:nvPr/>
        </p:nvPicPr>
        <p:blipFill>
          <a:blip r:embed="rId4"/>
          <a:stretch/>
        </p:blipFill>
        <p:spPr>
          <a:xfrm>
            <a:off x="4597560" y="193680"/>
            <a:ext cx="3136680" cy="3137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" descr=""/>
          <p:cNvPicPr/>
          <p:nvPr/>
        </p:nvPicPr>
        <p:blipFill>
          <a:blip r:embed="rId1"/>
          <a:stretch/>
        </p:blipFill>
        <p:spPr>
          <a:xfrm>
            <a:off x="-380880" y="2971800"/>
            <a:ext cx="4657680" cy="3278160"/>
          </a:xfrm>
          <a:prstGeom prst="rect">
            <a:avLst/>
          </a:prstGeom>
          <a:ln w="0">
            <a:noFill/>
          </a:ln>
        </p:spPr>
      </p:pic>
      <p:sp>
        <p:nvSpPr>
          <p:cNvPr id="67" name=""/>
          <p:cNvSpPr/>
          <p:nvPr/>
        </p:nvSpPr>
        <p:spPr>
          <a:xfrm>
            <a:off x="1163520" y="3768840"/>
            <a:ext cx="2971800" cy="2388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8" name="" descr=""/>
          <p:cNvPicPr/>
          <p:nvPr/>
        </p:nvPicPr>
        <p:blipFill>
          <a:blip r:embed="rId2"/>
          <a:stretch/>
        </p:blipFill>
        <p:spPr>
          <a:xfrm>
            <a:off x="399960" y="-314280"/>
            <a:ext cx="4297320" cy="3362400"/>
          </a:xfrm>
          <a:prstGeom prst="rect">
            <a:avLst/>
          </a:prstGeom>
          <a:ln w="0">
            <a:noFill/>
          </a:ln>
        </p:spPr>
      </p:pic>
      <p:sp>
        <p:nvSpPr>
          <p:cNvPr id="69" name=""/>
          <p:cNvSpPr/>
          <p:nvPr/>
        </p:nvSpPr>
        <p:spPr>
          <a:xfrm>
            <a:off x="1249200" y="457200"/>
            <a:ext cx="2713320" cy="2590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0" name="" descr=""/>
          <p:cNvPicPr/>
          <p:nvPr/>
        </p:nvPicPr>
        <p:blipFill>
          <a:blip r:embed="rId3"/>
          <a:stretch/>
        </p:blipFill>
        <p:spPr>
          <a:xfrm>
            <a:off x="85680" y="-299880"/>
            <a:ext cx="4238640" cy="3309840"/>
          </a:xfrm>
          <a:prstGeom prst="rect">
            <a:avLst/>
          </a:prstGeom>
          <a:ln w="0">
            <a:noFill/>
          </a:ln>
        </p:spPr>
      </p:pic>
      <p:pic>
        <p:nvPicPr>
          <p:cNvPr id="71" name="" descr=""/>
          <p:cNvPicPr/>
          <p:nvPr/>
        </p:nvPicPr>
        <p:blipFill>
          <a:blip r:embed="rId4"/>
          <a:stretch/>
        </p:blipFill>
        <p:spPr>
          <a:xfrm>
            <a:off x="4467240" y="3068640"/>
            <a:ext cx="4592520" cy="3255840"/>
          </a:xfrm>
          <a:prstGeom prst="rect">
            <a:avLst/>
          </a:prstGeom>
          <a:ln w="0">
            <a:noFill/>
          </a:ln>
        </p:spPr>
      </p:pic>
      <p:pic>
        <p:nvPicPr>
          <p:cNvPr id="72" name="" descr=""/>
          <p:cNvPicPr/>
          <p:nvPr/>
        </p:nvPicPr>
        <p:blipFill>
          <a:blip r:embed="rId5"/>
          <a:stretch/>
        </p:blipFill>
        <p:spPr>
          <a:xfrm>
            <a:off x="4552920" y="-28440"/>
            <a:ext cx="3981600" cy="3047760"/>
          </a:xfrm>
          <a:prstGeom prst="rect">
            <a:avLst/>
          </a:prstGeom>
          <a:ln w="0">
            <a:noFill/>
          </a:ln>
        </p:spPr>
      </p:pic>
      <p:sp>
        <p:nvSpPr>
          <p:cNvPr id="73" name=""/>
          <p:cNvSpPr/>
          <p:nvPr/>
        </p:nvSpPr>
        <p:spPr>
          <a:xfrm>
            <a:off x="6249240" y="3581280"/>
            <a:ext cx="893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emal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2058120" y="3505320"/>
            <a:ext cx="893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emal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6365160" y="228600"/>
            <a:ext cx="676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al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2180520" y="228600"/>
            <a:ext cx="676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al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2047320" y="7920"/>
            <a:ext cx="923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Z-scor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5954760" y="0"/>
            <a:ext cx="1436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qRT-PCR (2</a:t>
            </a:r>
            <a:r>
              <a:rPr b="1" lang="en-US" sz="1400" spc="-1" strike="noStrike" baseline="30000">
                <a:solidFill>
                  <a:srgbClr val="000000"/>
                </a:solidFill>
                <a:latin typeface="Arial"/>
              </a:rPr>
              <a:t>-</a:t>
            </a:r>
            <a:r>
              <a:rPr b="1" lang="en-US" sz="1400" spc="-1" strike="noStrike" baseline="30000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1" lang="en-US" sz="1400" spc="-1" strike="noStrike" baseline="30000">
                <a:solidFill>
                  <a:srgbClr val="000000"/>
                </a:solidFill>
                <a:latin typeface="Arial"/>
              </a:rPr>
              <a:t>Ct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1152360" y="533520"/>
            <a:ext cx="1800" cy="243828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2352600" y="533520"/>
            <a:ext cx="1800" cy="243828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2657520" y="533520"/>
            <a:ext cx="1440" cy="243828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3257640" y="533520"/>
            <a:ext cx="1440" cy="243828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3" name="" descr=""/>
          <p:cNvPicPr/>
          <p:nvPr/>
        </p:nvPicPr>
        <p:blipFill>
          <a:blip r:embed="rId6"/>
          <a:stretch/>
        </p:blipFill>
        <p:spPr>
          <a:xfrm>
            <a:off x="131760" y="2971800"/>
            <a:ext cx="4135320" cy="3228840"/>
          </a:xfrm>
          <a:prstGeom prst="rect">
            <a:avLst/>
          </a:prstGeom>
          <a:ln w="0">
            <a:noFill/>
          </a:ln>
        </p:spPr>
      </p:pic>
      <p:sp>
        <p:nvSpPr>
          <p:cNvPr id="84" name=""/>
          <p:cNvSpPr/>
          <p:nvPr/>
        </p:nvSpPr>
        <p:spPr>
          <a:xfrm>
            <a:off x="2343240" y="3781440"/>
            <a:ext cx="1440" cy="243828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2638440" y="3781440"/>
            <a:ext cx="1440" cy="243828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3228840" y="3790800"/>
            <a:ext cx="1800" cy="243864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1162080" y="3781440"/>
            <a:ext cx="1440" cy="243828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 rot="18017400">
            <a:off x="636120" y="296208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irk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 rot="18017400">
            <a:off x="820080" y="3051360"/>
            <a:ext cx="72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NCA (a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 rot="18017400">
            <a:off x="1110240" y="3052800"/>
            <a:ext cx="73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NCA (b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 rot="18017400">
            <a:off x="1418760" y="3051360"/>
            <a:ext cx="72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NCA (c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 rot="18017400">
            <a:off x="1711800" y="3022920"/>
            <a:ext cx="73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NCA (d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 rot="18017400">
            <a:off x="2216160" y="295416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IP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 rot="18017400">
            <a:off x="2316600" y="3056760"/>
            <a:ext cx="74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INK1 (a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 rot="18017400">
            <a:off x="2571840" y="3050640"/>
            <a:ext cx="750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INK1 (b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 rot="18017400">
            <a:off x="3156480" y="2953080"/>
            <a:ext cx="45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DJ-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 rot="18017400">
            <a:off x="3244680" y="3052800"/>
            <a:ext cx="735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TP13A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 rot="18017400">
            <a:off x="3476880" y="3078360"/>
            <a:ext cx="79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AP1GA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 rot="18017400">
            <a:off x="623160" y="617724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irk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 rot="18017400">
            <a:off x="807480" y="6266160"/>
            <a:ext cx="72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NCA (a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 rot="18017400">
            <a:off x="1097640" y="6267600"/>
            <a:ext cx="73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NCA (b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 rot="18017400">
            <a:off x="1405800" y="6266160"/>
            <a:ext cx="72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NCA (c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 rot="18017400">
            <a:off x="1668960" y="6248520"/>
            <a:ext cx="73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NCA (d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 rot="18017400">
            <a:off x="2203560" y="616896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IP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 rot="18017400">
            <a:off x="2304000" y="6271560"/>
            <a:ext cx="74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INK1 (a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 rot="18017400">
            <a:off x="2559240" y="6265080"/>
            <a:ext cx="750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INK1 (b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 rot="18017400">
            <a:off x="3143520" y="6167520"/>
            <a:ext cx="45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DJ-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 rot="18017400">
            <a:off x="3222360" y="6267600"/>
            <a:ext cx="735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TP13A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 rot="18017400">
            <a:off x="3463920" y="6292800"/>
            <a:ext cx="79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AP1GA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 rot="18017400">
            <a:off x="4868280" y="297684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irk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 rot="18017400">
            <a:off x="5358960" y="2978280"/>
            <a:ext cx="53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NC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 rot="18017400">
            <a:off x="5911920" y="294948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IP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 rot="18017400">
            <a:off x="6323400" y="2995200"/>
            <a:ext cx="552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INK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 rot="18017400">
            <a:off x="6890040" y="2948040"/>
            <a:ext cx="45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DJ-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 rot="18017400">
            <a:off x="7184880" y="3048120"/>
            <a:ext cx="735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TP13A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 rot="18017400">
            <a:off x="7628040" y="3053160"/>
            <a:ext cx="79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AP1GA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 rot="18017400">
            <a:off x="4827240" y="627192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irk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 rot="18017400">
            <a:off x="5317560" y="6274440"/>
            <a:ext cx="53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NC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 rot="18017400">
            <a:off x="5870520" y="624456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IP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 rot="18017400">
            <a:off x="6282000" y="6290640"/>
            <a:ext cx="552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INK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 rot="18017400">
            <a:off x="6849000" y="6243840"/>
            <a:ext cx="45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DJ-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 rot="18017400">
            <a:off x="7143480" y="6343920"/>
            <a:ext cx="735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TP13A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 rot="18017400">
            <a:off x="7588440" y="6347160"/>
            <a:ext cx="79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AP1GA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-19080" y="22320"/>
            <a:ext cx="2050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 Figure 7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5" name="" descr=""/>
          <p:cNvPicPr/>
          <p:nvPr/>
        </p:nvPicPr>
        <p:blipFill>
          <a:blip r:embed="rId1"/>
          <a:stretch/>
        </p:blipFill>
        <p:spPr>
          <a:xfrm>
            <a:off x="4648320" y="3048120"/>
            <a:ext cx="3411360" cy="3124080"/>
          </a:xfrm>
          <a:prstGeom prst="rect">
            <a:avLst/>
          </a:prstGeom>
          <a:ln w="0">
            <a:noFill/>
          </a:ln>
        </p:spPr>
      </p:pic>
      <p:pic>
        <p:nvPicPr>
          <p:cNvPr id="126" name="" descr=""/>
          <p:cNvPicPr/>
          <p:nvPr/>
        </p:nvPicPr>
        <p:blipFill>
          <a:blip r:embed="rId2"/>
          <a:stretch/>
        </p:blipFill>
        <p:spPr>
          <a:xfrm>
            <a:off x="1143000" y="3000240"/>
            <a:ext cx="3429000" cy="3175200"/>
          </a:xfrm>
          <a:prstGeom prst="rect">
            <a:avLst/>
          </a:prstGeom>
          <a:ln w="0">
            <a:noFill/>
          </a:ln>
        </p:spPr>
      </p:pic>
      <p:pic>
        <p:nvPicPr>
          <p:cNvPr id="127" name="" descr=""/>
          <p:cNvPicPr/>
          <p:nvPr/>
        </p:nvPicPr>
        <p:blipFill>
          <a:blip r:embed="rId3"/>
          <a:stretch/>
        </p:blipFill>
        <p:spPr>
          <a:xfrm>
            <a:off x="1152360" y="-266760"/>
            <a:ext cx="3419640" cy="3213000"/>
          </a:xfrm>
          <a:prstGeom prst="rect">
            <a:avLst/>
          </a:prstGeom>
          <a:ln w="0">
            <a:noFill/>
          </a:ln>
        </p:spPr>
      </p:pic>
      <p:pic>
        <p:nvPicPr>
          <p:cNvPr id="128" name="" descr=""/>
          <p:cNvPicPr/>
          <p:nvPr/>
        </p:nvPicPr>
        <p:blipFill>
          <a:blip r:embed="rId4"/>
          <a:stretch/>
        </p:blipFill>
        <p:spPr>
          <a:xfrm>
            <a:off x="4648320" y="-228600"/>
            <a:ext cx="3352680" cy="3184560"/>
          </a:xfrm>
          <a:prstGeom prst="rect">
            <a:avLst/>
          </a:prstGeom>
          <a:ln w="0">
            <a:noFill/>
          </a:ln>
        </p:spPr>
      </p:pic>
      <p:sp>
        <p:nvSpPr>
          <p:cNvPr id="129" name=""/>
          <p:cNvSpPr/>
          <p:nvPr/>
        </p:nvSpPr>
        <p:spPr>
          <a:xfrm>
            <a:off x="5896800" y="228600"/>
            <a:ext cx="676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al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2353320" y="228600"/>
            <a:ext cx="676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al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2220480" y="7920"/>
            <a:ext cx="923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Z-scor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5486400" y="0"/>
            <a:ext cx="1436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qRT-PCR (2</a:t>
            </a:r>
            <a:r>
              <a:rPr b="1" lang="en-US" sz="1400" spc="-1" strike="noStrike" baseline="30000">
                <a:solidFill>
                  <a:srgbClr val="000000"/>
                </a:solidFill>
                <a:latin typeface="Arial"/>
              </a:rPr>
              <a:t>-</a:t>
            </a:r>
            <a:r>
              <a:rPr b="1" lang="en-US" sz="1400" spc="-1" strike="noStrike" baseline="30000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1" lang="en-US" sz="1400" spc="-1" strike="noStrike" baseline="30000">
                <a:solidFill>
                  <a:srgbClr val="000000"/>
                </a:solidFill>
                <a:latin typeface="Arial"/>
              </a:rPr>
              <a:t>Ct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5734800" y="3505320"/>
            <a:ext cx="893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emal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2248560" y="3498840"/>
            <a:ext cx="893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emal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 rot="18017400">
            <a:off x="1463400" y="2799360"/>
            <a:ext cx="366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T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 rot="18017400">
            <a:off x="1816920" y="2873520"/>
            <a:ext cx="609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Parki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 rot="18017400">
            <a:off x="2339280" y="2883240"/>
            <a:ext cx="609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RIMS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 rot="18017400">
            <a:off x="2723400" y="2957760"/>
            <a:ext cx="820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RIMS3 (a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 rot="18017400">
            <a:off x="3197880" y="2960640"/>
            <a:ext cx="828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RIMS3 (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 rot="18017400">
            <a:off x="1431720" y="6076080"/>
            <a:ext cx="366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T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 rot="18017400">
            <a:off x="1774080" y="6161400"/>
            <a:ext cx="609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Parki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 rot="18017400">
            <a:off x="2307240" y="6159600"/>
            <a:ext cx="609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RIMS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 rot="18017400">
            <a:off x="2691720" y="6234480"/>
            <a:ext cx="820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RIMS3 (a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 rot="18017400">
            <a:off x="3165840" y="6236640"/>
            <a:ext cx="828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RIMS3 (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 rot="18017400">
            <a:off x="4992480" y="2810520"/>
            <a:ext cx="366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T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 rot="18017400">
            <a:off x="5236200" y="2914920"/>
            <a:ext cx="609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Parki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 rot="18017400">
            <a:off x="5764320" y="2916360"/>
            <a:ext cx="645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LRRK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 rot="18017400">
            <a:off x="6303240" y="2918160"/>
            <a:ext cx="609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RIMS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 rot="18017400">
            <a:off x="6804720" y="2914920"/>
            <a:ext cx="609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RIMS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 rot="18017400">
            <a:off x="4979880" y="6045840"/>
            <a:ext cx="366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T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 rot="18017400">
            <a:off x="5236200" y="6150240"/>
            <a:ext cx="609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Parki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 rot="18017400">
            <a:off x="5751360" y="6166440"/>
            <a:ext cx="645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LRRK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 rot="18017400">
            <a:off x="6303240" y="6150240"/>
            <a:ext cx="609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RIMS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 rot="18017400">
            <a:off x="6792120" y="6150240"/>
            <a:ext cx="609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RIMS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0" y="22320"/>
            <a:ext cx="2041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 Figure 7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8-14T22:52:05Z</dcterms:created>
  <dc:creator>Kai Sonntag</dc:creator>
  <dc:description/>
  <dc:language>en-US</dc:language>
  <cp:lastModifiedBy>Kai Sonntag</cp:lastModifiedBy>
  <dcterms:modified xsi:type="dcterms:W3CDTF">2009-09-07T21:32:22Z</dcterms:modified>
  <cp:revision>39</cp:revision>
  <dc:subject/>
  <dc:title>PowerPoint Presentation</dc:title>
</cp:coreProperties>
</file>